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notesSlides/notesSlide2.xml" ContentType="application/vnd.openxmlformats-officedocument.presentationml.notesSlide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84" r:id="rId2"/>
    <p:sldId id="286" r:id="rId3"/>
    <p:sldId id="287" r:id="rId4"/>
    <p:sldId id="288" r:id="rId5"/>
    <p:sldId id="289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853" autoAdjust="0"/>
  </p:normalViewPr>
  <p:slideViewPr>
    <p:cSldViewPr snapToGrid="0" snapToObjects="1" showGuides="1">
      <p:cViewPr varScale="1">
        <p:scale>
          <a:sx n="116" d="100"/>
          <a:sy n="116" d="100"/>
        </p:scale>
        <p:origin x="-1128" y="-104"/>
      </p:cViewPr>
      <p:guideLst>
        <p:guide orient="horz" pos="4319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skildum:Documents:Research:qPCR%20arrays:final%20glucose%20array%20data:10-16-13TamR+E_MCC+EPCRArrayFINALE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skildum:Documents:Research:will%20walter:11-13-14%20PDH%20acivity%20TRIPLICATES%20ww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skildum:Documents:Research:7-11-2014%20qPCR%20PDK4%20actin%20PDK4%20siRN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skildum:Documents:Research:9-19-2014%20SRB%20assay%20PDK4%20siRN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5651391340114"/>
          <c:y val="0.0523415801946197"/>
          <c:w val="0.809313826032911"/>
          <c:h val="0.81907223621349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xVal>
            <c:numRef>
              <c:f>'Volcano Plot'!$M$7:$M$90</c:f>
              <c:numCache>
                <c:formatCode>0.00</c:formatCode>
                <c:ptCount val="84"/>
                <c:pt idx="0">
                  <c:v>0.248000000000001</c:v>
                </c:pt>
                <c:pt idx="1">
                  <c:v>-0.0186666666666646</c:v>
                </c:pt>
                <c:pt idx="2">
                  <c:v>0.281333333333335</c:v>
                </c:pt>
                <c:pt idx="3">
                  <c:v>0.171333333333334</c:v>
                </c:pt>
                <c:pt idx="4">
                  <c:v>0.208000000000003</c:v>
                </c:pt>
                <c:pt idx="5">
                  <c:v>0.651333333333335</c:v>
                </c:pt>
                <c:pt idx="6">
                  <c:v>-0.438666666666666</c:v>
                </c:pt>
                <c:pt idx="7">
                  <c:v>-0.585333333333332</c:v>
                </c:pt>
                <c:pt idx="8">
                  <c:v>0.0313333333333346</c:v>
                </c:pt>
                <c:pt idx="9">
                  <c:v>-0.151999999999998</c:v>
                </c:pt>
                <c:pt idx="10">
                  <c:v>-0.528666666666663</c:v>
                </c:pt>
                <c:pt idx="11">
                  <c:v>-0.221999999999997</c:v>
                </c:pt>
                <c:pt idx="12">
                  <c:v>0.591333333333336</c:v>
                </c:pt>
                <c:pt idx="13">
                  <c:v>1.151333333333335</c:v>
                </c:pt>
                <c:pt idx="14">
                  <c:v>0.558000000000002</c:v>
                </c:pt>
                <c:pt idx="15">
                  <c:v>0.788000000000001</c:v>
                </c:pt>
                <c:pt idx="16">
                  <c:v>0.228000000000002</c:v>
                </c:pt>
                <c:pt idx="17">
                  <c:v>0.10466666666667</c:v>
                </c:pt>
                <c:pt idx="18">
                  <c:v>1.198000000000005</c:v>
                </c:pt>
                <c:pt idx="19">
                  <c:v>0.568000000000003</c:v>
                </c:pt>
                <c:pt idx="20">
                  <c:v>-0.321999999999998</c:v>
                </c:pt>
                <c:pt idx="21">
                  <c:v>-0.475333333333332</c:v>
                </c:pt>
                <c:pt idx="22">
                  <c:v>0.974666666666669</c:v>
                </c:pt>
                <c:pt idx="23">
                  <c:v>-2.058666666666663</c:v>
                </c:pt>
                <c:pt idx="24">
                  <c:v>0.398000000000003</c:v>
                </c:pt>
                <c:pt idx="25">
                  <c:v>0.304666666666669</c:v>
                </c:pt>
                <c:pt idx="26">
                  <c:v>-0.02533333333333</c:v>
                </c:pt>
                <c:pt idx="27">
                  <c:v>0.414666666666669</c:v>
                </c:pt>
                <c:pt idx="28">
                  <c:v>0.394666666666666</c:v>
                </c:pt>
                <c:pt idx="29">
                  <c:v>0.364666666666669</c:v>
                </c:pt>
                <c:pt idx="30">
                  <c:v>0.408000000000004</c:v>
                </c:pt>
                <c:pt idx="31">
                  <c:v>0.281333333333336</c:v>
                </c:pt>
                <c:pt idx="32">
                  <c:v>0.0513333333333342</c:v>
                </c:pt>
                <c:pt idx="33">
                  <c:v>-0.401999999999996</c:v>
                </c:pt>
                <c:pt idx="34">
                  <c:v>-0.185333333333331</c:v>
                </c:pt>
                <c:pt idx="35">
                  <c:v>-0.275333333333331</c:v>
                </c:pt>
                <c:pt idx="36">
                  <c:v>-0.0819999999999974</c:v>
                </c:pt>
                <c:pt idx="37">
                  <c:v>0.104666666666668</c:v>
                </c:pt>
                <c:pt idx="38">
                  <c:v>-0.388666666666666</c:v>
                </c:pt>
                <c:pt idx="39">
                  <c:v>-0.458666666666663</c:v>
                </c:pt>
                <c:pt idx="40">
                  <c:v>0.174666666666668</c:v>
                </c:pt>
                <c:pt idx="41">
                  <c:v>-0.931999999999997</c:v>
                </c:pt>
                <c:pt idx="42">
                  <c:v>0.204666666666671</c:v>
                </c:pt>
                <c:pt idx="43">
                  <c:v>-0.815333333333331</c:v>
                </c:pt>
                <c:pt idx="44">
                  <c:v>0.268000000000002</c:v>
                </c:pt>
                <c:pt idx="45">
                  <c:v>-0.138666666666665</c:v>
                </c:pt>
                <c:pt idx="46">
                  <c:v>0.984666666666671</c:v>
                </c:pt>
                <c:pt idx="47">
                  <c:v>-0.541999999999997</c:v>
                </c:pt>
                <c:pt idx="48">
                  <c:v>0.134666666666668</c:v>
                </c:pt>
                <c:pt idx="49">
                  <c:v>1.691333333333335</c:v>
                </c:pt>
                <c:pt idx="50">
                  <c:v>0.408000000000001</c:v>
                </c:pt>
                <c:pt idx="51">
                  <c:v>-0.151999999999999</c:v>
                </c:pt>
                <c:pt idx="52">
                  <c:v>0.294666666666669</c:v>
                </c:pt>
                <c:pt idx="53">
                  <c:v>0.668000000000002</c:v>
                </c:pt>
                <c:pt idx="54">
                  <c:v>0.261333333333334</c:v>
                </c:pt>
                <c:pt idx="55">
                  <c:v>0.128000000000006</c:v>
                </c:pt>
                <c:pt idx="56">
                  <c:v>-0.12533333333333</c:v>
                </c:pt>
                <c:pt idx="57">
                  <c:v>1.808000000000004</c:v>
                </c:pt>
                <c:pt idx="58">
                  <c:v>0.148000000000003</c:v>
                </c:pt>
                <c:pt idx="59">
                  <c:v>0.284666666666668</c:v>
                </c:pt>
                <c:pt idx="60">
                  <c:v>0.158000000000003</c:v>
                </c:pt>
                <c:pt idx="61">
                  <c:v>0.158000000000002</c:v>
                </c:pt>
                <c:pt idx="62">
                  <c:v>0.114666666666671</c:v>
                </c:pt>
                <c:pt idx="63">
                  <c:v>-0.171999999999998</c:v>
                </c:pt>
                <c:pt idx="64">
                  <c:v>0.101333333333336</c:v>
                </c:pt>
                <c:pt idx="65">
                  <c:v>0.17466666666667</c:v>
                </c:pt>
                <c:pt idx="66">
                  <c:v>0.324666666666667</c:v>
                </c:pt>
                <c:pt idx="67">
                  <c:v>0.511333333333336</c:v>
                </c:pt>
                <c:pt idx="68">
                  <c:v>-0.561999999999999</c:v>
                </c:pt>
                <c:pt idx="69">
                  <c:v>-0.00533333333333008</c:v>
                </c:pt>
                <c:pt idx="70">
                  <c:v>0.814666666666669</c:v>
                </c:pt>
                <c:pt idx="71">
                  <c:v>0.188000000000001</c:v>
                </c:pt>
                <c:pt idx="72">
                  <c:v>0.518000000000001</c:v>
                </c:pt>
                <c:pt idx="73">
                  <c:v>-0.182</c:v>
                </c:pt>
                <c:pt idx="74">
                  <c:v>0.124666666666668</c:v>
                </c:pt>
                <c:pt idx="75">
                  <c:v>0.0246666666666691</c:v>
                </c:pt>
                <c:pt idx="76">
                  <c:v>-0.361999999999997</c:v>
                </c:pt>
                <c:pt idx="77">
                  <c:v>0.118000000000002</c:v>
                </c:pt>
                <c:pt idx="78">
                  <c:v>0.304666666666668</c:v>
                </c:pt>
                <c:pt idx="79">
                  <c:v>0.00466666666667012</c:v>
                </c:pt>
                <c:pt idx="80">
                  <c:v>-0.321999999999998</c:v>
                </c:pt>
                <c:pt idx="81">
                  <c:v>0.314666666666669</c:v>
                </c:pt>
                <c:pt idx="82">
                  <c:v>0.0313333333333371</c:v>
                </c:pt>
                <c:pt idx="83">
                  <c:v>-0.191999999999997</c:v>
                </c:pt>
              </c:numCache>
            </c:numRef>
          </c:xVal>
          <c:yVal>
            <c:numRef>
              <c:f>'Volcano Plot'!$N$7:$N$90</c:f>
              <c:numCache>
                <c:formatCode>0.0E+00</c:formatCode>
                <c:ptCount val="84"/>
                <c:pt idx="0">
                  <c:v>0.338799444991618</c:v>
                </c:pt>
                <c:pt idx="1">
                  <c:v>0.955742302071702</c:v>
                </c:pt>
                <c:pt idx="2">
                  <c:v>0.000240943132208782</c:v>
                </c:pt>
                <c:pt idx="3">
                  <c:v>0.556070810062075</c:v>
                </c:pt>
                <c:pt idx="4">
                  <c:v>0.389562991835915</c:v>
                </c:pt>
                <c:pt idx="5">
                  <c:v>0.451402818678097</c:v>
                </c:pt>
                <c:pt idx="6">
                  <c:v>0.0113885035877492</c:v>
                </c:pt>
                <c:pt idx="7">
                  <c:v>0.00167822625174868</c:v>
                </c:pt>
                <c:pt idx="8">
                  <c:v>0.569073262921417</c:v>
                </c:pt>
                <c:pt idx="9">
                  <c:v>0.0491891344640534</c:v>
                </c:pt>
                <c:pt idx="10">
                  <c:v>0.129704258658608</c:v>
                </c:pt>
                <c:pt idx="11">
                  <c:v>0.285474462527089</c:v>
                </c:pt>
                <c:pt idx="12">
                  <c:v>0.413798026250152</c:v>
                </c:pt>
                <c:pt idx="13">
                  <c:v>0.00947494699508073</c:v>
                </c:pt>
                <c:pt idx="14">
                  <c:v>0.0756709057350502</c:v>
                </c:pt>
                <c:pt idx="15">
                  <c:v>0.00421776707851095</c:v>
                </c:pt>
                <c:pt idx="16">
                  <c:v>0.511856753531837</c:v>
                </c:pt>
                <c:pt idx="17">
                  <c:v>0.872744028668135</c:v>
                </c:pt>
                <c:pt idx="18">
                  <c:v>0.266970722122812</c:v>
                </c:pt>
                <c:pt idx="19">
                  <c:v>0.21529530085957</c:v>
                </c:pt>
                <c:pt idx="20">
                  <c:v>0.620903669676218</c:v>
                </c:pt>
                <c:pt idx="21">
                  <c:v>0.195580855801953</c:v>
                </c:pt>
                <c:pt idx="22">
                  <c:v>0.161234490785055</c:v>
                </c:pt>
                <c:pt idx="23">
                  <c:v>0.000577559036507819</c:v>
                </c:pt>
                <c:pt idx="24">
                  <c:v>0.250987849576272</c:v>
                </c:pt>
                <c:pt idx="25">
                  <c:v>0.0854011378796988</c:v>
                </c:pt>
                <c:pt idx="26">
                  <c:v>0.885742339647343</c:v>
                </c:pt>
                <c:pt idx="27">
                  <c:v>0.350093597192469</c:v>
                </c:pt>
                <c:pt idx="28">
                  <c:v>0.501832321534814</c:v>
                </c:pt>
                <c:pt idx="29">
                  <c:v>0.0746402020188978</c:v>
                </c:pt>
                <c:pt idx="30">
                  <c:v>0.667577350840061</c:v>
                </c:pt>
                <c:pt idx="31">
                  <c:v>0.479354549172088</c:v>
                </c:pt>
                <c:pt idx="32">
                  <c:v>0.974934862528124</c:v>
                </c:pt>
                <c:pt idx="33">
                  <c:v>0.529094905793143</c:v>
                </c:pt>
                <c:pt idx="34">
                  <c:v>0.352766236787989</c:v>
                </c:pt>
                <c:pt idx="35">
                  <c:v>0.239115892111208</c:v>
                </c:pt>
                <c:pt idx="36">
                  <c:v>0.416033684030019</c:v>
                </c:pt>
                <c:pt idx="37">
                  <c:v>0.812761241344948</c:v>
                </c:pt>
                <c:pt idx="38">
                  <c:v>0.783598685506632</c:v>
                </c:pt>
                <c:pt idx="39">
                  <c:v>0.0682923452500619</c:v>
                </c:pt>
                <c:pt idx="40">
                  <c:v>0.276951187111189</c:v>
                </c:pt>
                <c:pt idx="41">
                  <c:v>0.0151233938334427</c:v>
                </c:pt>
                <c:pt idx="42">
                  <c:v>0.716981664654809</c:v>
                </c:pt>
                <c:pt idx="43">
                  <c:v>0.00862300648521293</c:v>
                </c:pt>
                <c:pt idx="44">
                  <c:v>0.0524109680876323</c:v>
                </c:pt>
                <c:pt idx="45">
                  <c:v>0.76341683849191</c:v>
                </c:pt>
                <c:pt idx="46">
                  <c:v>0.191388298356785</c:v>
                </c:pt>
                <c:pt idx="47">
                  <c:v>0.0998836104397181</c:v>
                </c:pt>
                <c:pt idx="48">
                  <c:v>0.792254298476803</c:v>
                </c:pt>
                <c:pt idx="49">
                  <c:v>0.00343609736842491</c:v>
                </c:pt>
                <c:pt idx="50">
                  <c:v>0.0402952748762631</c:v>
                </c:pt>
                <c:pt idx="51">
                  <c:v>0.77287185943215</c:v>
                </c:pt>
                <c:pt idx="52">
                  <c:v>0.425131303458055</c:v>
                </c:pt>
                <c:pt idx="53">
                  <c:v>0.29366986606193</c:v>
                </c:pt>
                <c:pt idx="54">
                  <c:v>0.0541653030220893</c:v>
                </c:pt>
                <c:pt idx="55">
                  <c:v>0.849301402118807</c:v>
                </c:pt>
                <c:pt idx="56">
                  <c:v>0.168517281804034</c:v>
                </c:pt>
                <c:pt idx="57">
                  <c:v>6.0503798924302E-6</c:v>
                </c:pt>
                <c:pt idx="58">
                  <c:v>0.828553864504477</c:v>
                </c:pt>
                <c:pt idx="59">
                  <c:v>0.406907175548974</c:v>
                </c:pt>
                <c:pt idx="60">
                  <c:v>0.622096823753749</c:v>
                </c:pt>
                <c:pt idx="61">
                  <c:v>0.746902782215208</c:v>
                </c:pt>
                <c:pt idx="62">
                  <c:v>0.693209719731809</c:v>
                </c:pt>
                <c:pt idx="63">
                  <c:v>0.235760314986385</c:v>
                </c:pt>
                <c:pt idx="64">
                  <c:v>0.887739203734484</c:v>
                </c:pt>
                <c:pt idx="65">
                  <c:v>0.163539017809167</c:v>
                </c:pt>
                <c:pt idx="66">
                  <c:v>0.926254273582112</c:v>
                </c:pt>
                <c:pt idx="67">
                  <c:v>0.385530809134469</c:v>
                </c:pt>
                <c:pt idx="68">
                  <c:v>0.0427816423825109</c:v>
                </c:pt>
                <c:pt idx="69">
                  <c:v>0.83519651430254</c:v>
                </c:pt>
                <c:pt idx="70">
                  <c:v>0.402292508456457</c:v>
                </c:pt>
                <c:pt idx="71">
                  <c:v>0.776923333731309</c:v>
                </c:pt>
                <c:pt idx="72">
                  <c:v>0.0186104127125884</c:v>
                </c:pt>
                <c:pt idx="73">
                  <c:v>0.0796370474136259</c:v>
                </c:pt>
                <c:pt idx="74">
                  <c:v>0.624689436151198</c:v>
                </c:pt>
                <c:pt idx="75">
                  <c:v>0.984623749504617</c:v>
                </c:pt>
                <c:pt idx="76">
                  <c:v>0.645177566609555</c:v>
                </c:pt>
                <c:pt idx="77">
                  <c:v>0.799286317088869</c:v>
                </c:pt>
                <c:pt idx="78">
                  <c:v>0.0215054222087399</c:v>
                </c:pt>
                <c:pt idx="79">
                  <c:v>0.971685391493108</c:v>
                </c:pt>
                <c:pt idx="80">
                  <c:v>0.00155885869000677</c:v>
                </c:pt>
                <c:pt idx="81">
                  <c:v>0.58621441852216</c:v>
                </c:pt>
                <c:pt idx="82">
                  <c:v>0.898851890648315</c:v>
                </c:pt>
                <c:pt idx="83">
                  <c:v>0.532262904456689</c:v>
                </c:pt>
              </c:numCache>
            </c:numRef>
          </c:yVal>
          <c:smooth val="0"/>
        </c:ser>
        <c:ser>
          <c:idx val="1"/>
          <c:order val="1"/>
          <c:spPr>
            <a:ln w="3175">
              <a:solidFill>
                <a:srgbClr val="0000D4"/>
              </a:solidFill>
              <a:prstDash val="solid"/>
            </a:ln>
          </c:spPr>
          <c:marker>
            <c:symbol val="square"/>
            <c:size val="3"/>
            <c:spPr>
              <a:noFill/>
              <a:ln w="9525">
                <a:noFill/>
              </a:ln>
            </c:spPr>
          </c:marker>
          <c:xVal>
            <c:numRef>
              <c:f>'Volcano Plot'!$B$9:$B$10</c:f>
              <c:numCache>
                <c:formatCode>0.00</c:formatCode>
                <c:ptCount val="2"/>
                <c:pt idx="0">
                  <c:v>-13.0</c:v>
                </c:pt>
                <c:pt idx="1">
                  <c:v>12.0</c:v>
                </c:pt>
              </c:numCache>
            </c:numRef>
          </c:xVal>
          <c:yVal>
            <c:numRef>
              <c:f>'Volcano Plot'!$C$9:$C$10</c:f>
              <c:numCache>
                <c:formatCode>General</c:formatCode>
                <c:ptCount val="2"/>
                <c:pt idx="0">
                  <c:v>0.05</c:v>
                </c:pt>
                <c:pt idx="1">
                  <c:v>0.05</c:v>
                </c:pt>
              </c:numCache>
            </c:numRef>
          </c:yVal>
          <c:smooth val="0"/>
        </c:ser>
        <c:ser>
          <c:idx val="3"/>
          <c:order val="2"/>
          <c:spPr>
            <a:ln w="3175">
              <a:solidFill>
                <a:srgbClr val="000000"/>
              </a:solidFill>
              <a:prstDash val="solid"/>
            </a:ln>
          </c:spPr>
          <c:marker>
            <c:symbol val="x"/>
            <c:size val="3"/>
            <c:spPr>
              <a:noFill/>
              <a:ln w="9525">
                <a:noFill/>
              </a:ln>
            </c:spPr>
          </c:marker>
          <c:xVal>
            <c:numRef>
              <c:f>'Volcano Plot'!$E$12:$E$13</c:f>
              <c:numCache>
                <c:formatCode>General</c:formatCode>
                <c:ptCount val="2"/>
                <c:pt idx="0">
                  <c:v>0.0</c:v>
                </c:pt>
                <c:pt idx="1">
                  <c:v>0.0</c:v>
                </c:pt>
              </c:numCache>
            </c:numRef>
          </c:xVal>
          <c:yVal>
            <c:numRef>
              <c:f>'Volcano Plot'!$B$12:$B$13</c:f>
              <c:numCache>
                <c:formatCode>0.0E+00</c:formatCode>
                <c:ptCount val="2"/>
                <c:pt idx="0" formatCode="General">
                  <c:v>1.0</c:v>
                </c:pt>
                <c:pt idx="1">
                  <c:v>1.0E-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8233560"/>
        <c:axId val="-2088292248"/>
      </c:scatterChart>
      <c:valAx>
        <c:axId val="-2088233560"/>
        <c:scaling>
          <c:orientation val="minMax"/>
          <c:max val="10.0"/>
          <c:min val="-7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2(Fold Difference)</a:t>
                </a:r>
              </a:p>
            </c:rich>
          </c:tx>
          <c:layout>
            <c:manualLayout>
              <c:xMode val="edge"/>
              <c:yMode val="edge"/>
              <c:x val="0.383648847597794"/>
              <c:y val="0.942895989337946"/>
            </c:manualLayout>
          </c:layout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-2088292248"/>
        <c:crosses val="max"/>
        <c:crossBetween val="midCat"/>
        <c:majorUnit val="2.0"/>
        <c:minorUnit val="0.2"/>
      </c:valAx>
      <c:valAx>
        <c:axId val="-2088292248"/>
        <c:scaling>
          <c:logBase val="10.0"/>
          <c:orientation val="maxMin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 Value</a:t>
                </a:r>
              </a:p>
            </c:rich>
          </c:tx>
          <c:layout>
            <c:manualLayout>
              <c:xMode val="edge"/>
              <c:yMode val="edge"/>
              <c:x val="0.00785854616895874"/>
              <c:y val="0.402203639834277"/>
            </c:manualLayout>
          </c:layout>
          <c:overlay val="0"/>
          <c:spPr>
            <a:noFill/>
            <a:ln w="25400">
              <a:noFill/>
            </a:ln>
          </c:spPr>
        </c:title>
        <c:numFmt formatCode="0.E+0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-2088233560"/>
        <c:crossesAt val="-7.0"/>
        <c:crossBetween val="midCat"/>
      </c:valAx>
      <c:spPr>
        <a:noFill/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2000" b="0" i="0" u="none" strike="noStrike" baseline="0">
          <a:solidFill>
            <a:srgbClr val="000000"/>
          </a:solidFill>
          <a:latin typeface="Helvetica"/>
          <a:ea typeface="Arial"/>
          <a:cs typeface="Helvetica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7F7F7F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ormalized to protein'!$J$13:$J$18</c:f>
                <c:numCache>
                  <c:formatCode>General</c:formatCode>
                  <c:ptCount val="6"/>
                  <c:pt idx="0">
                    <c:v>0.1119925539449</c:v>
                  </c:pt>
                  <c:pt idx="1">
                    <c:v>1.567698453633306</c:v>
                  </c:pt>
                  <c:pt idx="2">
                    <c:v>1.279347370983608</c:v>
                  </c:pt>
                  <c:pt idx="3">
                    <c:v>2.822677538240184</c:v>
                  </c:pt>
                  <c:pt idx="4">
                    <c:v>0.376569539999681</c:v>
                  </c:pt>
                  <c:pt idx="5">
                    <c:v>0.766806344256364</c:v>
                  </c:pt>
                </c:numCache>
              </c:numRef>
            </c:plus>
            <c:minus>
              <c:numRef>
                <c:f>'normalized to protein'!$J$13:$J$18</c:f>
                <c:numCache>
                  <c:formatCode>General</c:formatCode>
                  <c:ptCount val="6"/>
                  <c:pt idx="0">
                    <c:v>0.1119925539449</c:v>
                  </c:pt>
                  <c:pt idx="1">
                    <c:v>1.567698453633306</c:v>
                  </c:pt>
                  <c:pt idx="2">
                    <c:v>1.279347370983608</c:v>
                  </c:pt>
                  <c:pt idx="3">
                    <c:v>2.822677538240184</c:v>
                  </c:pt>
                  <c:pt idx="4">
                    <c:v>0.376569539999681</c:v>
                  </c:pt>
                  <c:pt idx="5">
                    <c:v>0.766806344256364</c:v>
                  </c:pt>
                </c:numCache>
              </c:numRef>
            </c:minus>
          </c:errBars>
          <c:cat>
            <c:multiLvlStrRef>
              <c:f>'normalized to protein'!$G$13:$H$18</c:f>
              <c:multiLvlStrCache>
                <c:ptCount val="6"/>
                <c:lvl>
                  <c:pt idx="0">
                    <c:v>MCC</c:v>
                  </c:pt>
                  <c:pt idx="1">
                    <c:v>TamR</c:v>
                  </c:pt>
                  <c:pt idx="2">
                    <c:v>MCC</c:v>
                  </c:pt>
                  <c:pt idx="3">
                    <c:v>TamR</c:v>
                  </c:pt>
                  <c:pt idx="4">
                    <c:v>MCC</c:v>
                  </c:pt>
                  <c:pt idx="5">
                    <c:v>TamR</c:v>
                  </c:pt>
                </c:lvl>
                <c:lvl>
                  <c:pt idx="0">
                    <c:v>Thursday</c:v>
                  </c:pt>
                  <c:pt idx="2">
                    <c:v>Friday</c:v>
                  </c:pt>
                  <c:pt idx="4">
                    <c:v>Saturday</c:v>
                  </c:pt>
                </c:lvl>
              </c:multiLvlStrCache>
            </c:multiLvlStrRef>
          </c:cat>
          <c:val>
            <c:numRef>
              <c:f>'normalized to protein'!$I$13:$I$18</c:f>
              <c:numCache>
                <c:formatCode>General</c:formatCode>
                <c:ptCount val="6"/>
                <c:pt idx="0">
                  <c:v>12.69231473993594</c:v>
                </c:pt>
                <c:pt idx="1">
                  <c:v>21.27323699611832</c:v>
                </c:pt>
                <c:pt idx="2">
                  <c:v>12.27701133771977</c:v>
                </c:pt>
                <c:pt idx="3">
                  <c:v>22.22563075599338</c:v>
                </c:pt>
                <c:pt idx="4">
                  <c:v>10.73506852958643</c:v>
                </c:pt>
                <c:pt idx="5">
                  <c:v>23.008745548879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8757704"/>
        <c:axId val="-2088760696"/>
      </c:barChart>
      <c:catAx>
        <c:axId val="-2088757704"/>
        <c:scaling>
          <c:orientation val="minMax"/>
        </c:scaling>
        <c:delete val="0"/>
        <c:axPos val="b"/>
        <c:majorTickMark val="out"/>
        <c:minorTickMark val="none"/>
        <c:tickLblPos val="nextTo"/>
        <c:crossAx val="-2088760696"/>
        <c:crosses val="autoZero"/>
        <c:auto val="1"/>
        <c:lblAlgn val="ctr"/>
        <c:lblOffset val="100"/>
        <c:noMultiLvlLbl val="0"/>
      </c:catAx>
      <c:valAx>
        <c:axId val="-2088760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err="1"/>
                  <a:t>nmol</a:t>
                </a:r>
                <a:r>
                  <a:rPr lang="en-US" dirty="0"/>
                  <a:t> NADH / minute / </a:t>
                </a:r>
                <a:r>
                  <a:rPr lang="en-US" dirty="0">
                    <a:latin typeface="Symbol" charset="2"/>
                    <a:cs typeface="Symbol" charset="2"/>
                  </a:rPr>
                  <a:t>m</a:t>
                </a:r>
                <a:r>
                  <a:rPr lang="en-US" dirty="0"/>
                  <a:t>g protein</a:t>
                </a:r>
              </a:p>
            </c:rich>
          </c:tx>
          <c:layout>
            <c:manualLayout>
              <c:xMode val="edge"/>
              <c:yMode val="edge"/>
              <c:x val="0.0138078001244858"/>
              <c:y val="0.10291345954842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0887577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800" b="0">
          <a:ln>
            <a:noFill/>
          </a:ln>
          <a:latin typeface="Helvetica"/>
          <a:cs typeface="Helvetica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5776260560192"/>
          <c:y val="0.0387456133788758"/>
          <c:w val="0.7418500720937"/>
          <c:h val="0.8699282468518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32</c:f>
              <c:strCache>
                <c:ptCount val="1"/>
                <c:pt idx="0">
                  <c:v>control siRNA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32:$G$32</c:f>
                <c:numCache>
                  <c:formatCode>General</c:formatCode>
                  <c:ptCount val="2"/>
                  <c:pt idx="0">
                    <c:v>0.000318462659494227</c:v>
                  </c:pt>
                  <c:pt idx="1">
                    <c:v>0.000415565809046631</c:v>
                  </c:pt>
                </c:numCache>
              </c:numRef>
            </c:plus>
            <c:minus>
              <c:numRef>
                <c:f>Sheet1!$F$32:$G$32</c:f>
                <c:numCache>
                  <c:formatCode>General</c:formatCode>
                  <c:ptCount val="2"/>
                  <c:pt idx="0">
                    <c:v>0.000318462659494227</c:v>
                  </c:pt>
                  <c:pt idx="1">
                    <c:v>0.000415565809046631</c:v>
                  </c:pt>
                </c:numCache>
              </c:numRef>
            </c:minus>
          </c:errBars>
          <c:cat>
            <c:strRef>
              <c:f>Sheet1!$B$31:$C$31</c:f>
              <c:strCache>
                <c:ptCount val="2"/>
                <c:pt idx="0">
                  <c:v>EtOH</c:v>
                </c:pt>
                <c:pt idx="1">
                  <c:v>1nm dex</c:v>
                </c:pt>
              </c:strCache>
            </c:strRef>
          </c:cat>
          <c:val>
            <c:numRef>
              <c:f>Sheet1!$B$32:$C$32</c:f>
              <c:numCache>
                <c:formatCode>General</c:formatCode>
                <c:ptCount val="2"/>
                <c:pt idx="0">
                  <c:v>0.0010121114579568</c:v>
                </c:pt>
                <c:pt idx="1">
                  <c:v>0.00179635385697146</c:v>
                </c:pt>
              </c:numCache>
            </c:numRef>
          </c:val>
        </c:ser>
        <c:ser>
          <c:idx val="1"/>
          <c:order val="1"/>
          <c:tx>
            <c:strRef>
              <c:f>Sheet1!$A$33</c:f>
              <c:strCache>
                <c:ptCount val="1"/>
                <c:pt idx="0">
                  <c:v>PDK4 siRN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33:$G$33</c:f>
                <c:numCache>
                  <c:formatCode>General</c:formatCode>
                  <c:ptCount val="2"/>
                  <c:pt idx="0">
                    <c:v>0.000128357722208679</c:v>
                  </c:pt>
                  <c:pt idx="1">
                    <c:v>0.00010798812681388</c:v>
                  </c:pt>
                </c:numCache>
              </c:numRef>
            </c:plus>
            <c:minus>
              <c:numRef>
                <c:f>Sheet1!$F$33:$G$33</c:f>
                <c:numCache>
                  <c:formatCode>General</c:formatCode>
                  <c:ptCount val="2"/>
                  <c:pt idx="0">
                    <c:v>0.000128357722208679</c:v>
                  </c:pt>
                  <c:pt idx="1">
                    <c:v>0.00010798812681388</c:v>
                  </c:pt>
                </c:numCache>
              </c:numRef>
            </c:minus>
          </c:errBars>
          <c:cat>
            <c:strRef>
              <c:f>Sheet1!$B$31:$C$31</c:f>
              <c:strCache>
                <c:ptCount val="2"/>
                <c:pt idx="0">
                  <c:v>EtOH</c:v>
                </c:pt>
                <c:pt idx="1">
                  <c:v>1nm dex</c:v>
                </c:pt>
              </c:strCache>
            </c:strRef>
          </c:cat>
          <c:val>
            <c:numRef>
              <c:f>Sheet1!$B$33:$C$33</c:f>
              <c:numCache>
                <c:formatCode>General</c:formatCode>
                <c:ptCount val="2"/>
                <c:pt idx="0">
                  <c:v>0.000362575695546729</c:v>
                </c:pt>
                <c:pt idx="1">
                  <c:v>0.0003351269306988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3463544"/>
        <c:axId val="-2103466008"/>
      </c:barChart>
      <c:catAx>
        <c:axId val="-210346354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03466008"/>
        <c:crosses val="autoZero"/>
        <c:auto val="1"/>
        <c:lblAlgn val="ctr"/>
        <c:lblOffset val="100"/>
        <c:noMultiLvlLbl val="0"/>
      </c:catAx>
      <c:valAx>
        <c:axId val="-21034660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pies PDK4 mRNA / copies actin mRNA</a:t>
                </a:r>
              </a:p>
            </c:rich>
          </c:tx>
          <c:layout>
            <c:manualLayout>
              <c:xMode val="edge"/>
              <c:yMode val="edge"/>
              <c:x val="0.0137482210870919"/>
              <c:y val="0.117895060653654"/>
            </c:manualLayout>
          </c:layout>
          <c:overlay val="0"/>
        </c:title>
        <c:numFmt formatCode="0.0E+00" sourceLinked="0"/>
        <c:majorTickMark val="out"/>
        <c:minorTickMark val="none"/>
        <c:tickLblPos val="nextTo"/>
        <c:crossAx val="-210346354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33984574117052"/>
          <c:y val="0.0488244548748903"/>
          <c:w val="0.292742758749584"/>
          <c:h val="0.17229374023687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600" b="0">
          <a:latin typeface="Helvetica"/>
          <a:cs typeface="Helvetica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L$1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D9D9D9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O$16:$O$21</c:f>
                <c:numCache>
                  <c:formatCode>General</c:formatCode>
                  <c:ptCount val="6"/>
                  <c:pt idx="0">
                    <c:v>0.10234236416697</c:v>
                  </c:pt>
                  <c:pt idx="1">
                    <c:v>0.0329014307576533</c:v>
                  </c:pt>
                  <c:pt idx="2">
                    <c:v>0.200361646578722</c:v>
                  </c:pt>
                  <c:pt idx="3">
                    <c:v>0.0245864831331044</c:v>
                  </c:pt>
                  <c:pt idx="4">
                    <c:v>0.0391698284834391</c:v>
                  </c:pt>
                  <c:pt idx="5">
                    <c:v>0.0386866995796507</c:v>
                  </c:pt>
                </c:numCache>
              </c:numRef>
            </c:plus>
            <c:minus>
              <c:numRef>
                <c:f>Sheet1!$O$16:$O$21</c:f>
                <c:numCache>
                  <c:formatCode>General</c:formatCode>
                  <c:ptCount val="6"/>
                  <c:pt idx="0">
                    <c:v>0.10234236416697</c:v>
                  </c:pt>
                  <c:pt idx="1">
                    <c:v>0.0329014307576533</c:v>
                  </c:pt>
                  <c:pt idx="2">
                    <c:v>0.200361646578722</c:v>
                  </c:pt>
                  <c:pt idx="3">
                    <c:v>0.0245864831331044</c:v>
                  </c:pt>
                  <c:pt idx="4">
                    <c:v>0.0391698284834391</c:v>
                  </c:pt>
                  <c:pt idx="5">
                    <c:v>0.0386866995796507</c:v>
                  </c:pt>
                </c:numCache>
              </c:numRef>
            </c:minus>
          </c:errBars>
          <c:cat>
            <c:multiLvlStrRef>
              <c:f>Sheet1!$J$16:$K$21</c:f>
              <c:multiLvlStrCache>
                <c:ptCount val="6"/>
                <c:lvl>
                  <c:pt idx="0">
                    <c:v>0</c:v>
                  </c:pt>
                  <c:pt idx="1">
                    <c:v>1</c:v>
                  </c:pt>
                  <c:pt idx="2">
                    <c:v>5</c:v>
                  </c:pt>
                  <c:pt idx="3">
                    <c:v>0</c:v>
                  </c:pt>
                  <c:pt idx="4">
                    <c:v>1</c:v>
                  </c:pt>
                  <c:pt idx="5">
                    <c:v>5</c:v>
                  </c:pt>
                </c:lvl>
                <c:lvl>
                  <c:pt idx="0">
                    <c:v>MCC-MCF-7</c:v>
                  </c:pt>
                  <c:pt idx="3">
                    <c:v>TamR-MCF-7</c:v>
                  </c:pt>
                </c:lvl>
              </c:multiLvlStrCache>
            </c:multiLvlStrRef>
          </c:cat>
          <c:val>
            <c:numRef>
              <c:f>Sheet1!$L$16:$L$21</c:f>
              <c:numCache>
                <c:formatCode>General</c:formatCode>
                <c:ptCount val="6"/>
                <c:pt idx="0">
                  <c:v>1.0</c:v>
                </c:pt>
                <c:pt idx="1">
                  <c:v>1.103553777359379</c:v>
                </c:pt>
                <c:pt idx="2">
                  <c:v>0.596288910084106</c:v>
                </c:pt>
                <c:pt idx="3">
                  <c:v>1.0</c:v>
                </c:pt>
                <c:pt idx="4">
                  <c:v>0.943601429944595</c:v>
                </c:pt>
                <c:pt idx="5">
                  <c:v>0.886166042055923</c:v>
                </c:pt>
              </c:numCache>
            </c:numRef>
          </c:val>
        </c:ser>
        <c:ser>
          <c:idx val="1"/>
          <c:order val="1"/>
          <c:tx>
            <c:strRef>
              <c:f>Sheet1!$M$15</c:f>
              <c:strCache>
                <c:ptCount val="1"/>
                <c:pt idx="0">
                  <c:v>PDK4 siRN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P$16:$P$21</c:f>
                <c:numCache>
                  <c:formatCode>General</c:formatCode>
                  <c:ptCount val="6"/>
                  <c:pt idx="0">
                    <c:v>0.0260193446644438</c:v>
                  </c:pt>
                  <c:pt idx="1">
                    <c:v>0.147953823845682</c:v>
                  </c:pt>
                  <c:pt idx="2">
                    <c:v>0.0338813110450978</c:v>
                  </c:pt>
                  <c:pt idx="3">
                    <c:v>0.0245911198268253</c:v>
                  </c:pt>
                  <c:pt idx="4">
                    <c:v>0.0411809905714226</c:v>
                  </c:pt>
                  <c:pt idx="5">
                    <c:v>0.0335922308970963</c:v>
                  </c:pt>
                </c:numCache>
              </c:numRef>
            </c:plus>
            <c:minus>
              <c:numRef>
                <c:f>Sheet1!$P$16:$P$21</c:f>
                <c:numCache>
                  <c:formatCode>General</c:formatCode>
                  <c:ptCount val="6"/>
                  <c:pt idx="0">
                    <c:v>0.0260193446644438</c:v>
                  </c:pt>
                  <c:pt idx="1">
                    <c:v>0.147953823845682</c:v>
                  </c:pt>
                  <c:pt idx="2">
                    <c:v>0.0338813110450978</c:v>
                  </c:pt>
                  <c:pt idx="3">
                    <c:v>0.0245911198268253</c:v>
                  </c:pt>
                  <c:pt idx="4">
                    <c:v>0.0411809905714226</c:v>
                  </c:pt>
                  <c:pt idx="5">
                    <c:v>0.0335922308970963</c:v>
                  </c:pt>
                </c:numCache>
              </c:numRef>
            </c:minus>
          </c:errBars>
          <c:cat>
            <c:multiLvlStrRef>
              <c:f>Sheet1!$J$16:$K$21</c:f>
              <c:multiLvlStrCache>
                <c:ptCount val="6"/>
                <c:lvl>
                  <c:pt idx="0">
                    <c:v>0</c:v>
                  </c:pt>
                  <c:pt idx="1">
                    <c:v>1</c:v>
                  </c:pt>
                  <c:pt idx="2">
                    <c:v>5</c:v>
                  </c:pt>
                  <c:pt idx="3">
                    <c:v>0</c:v>
                  </c:pt>
                  <c:pt idx="4">
                    <c:v>1</c:v>
                  </c:pt>
                  <c:pt idx="5">
                    <c:v>5</c:v>
                  </c:pt>
                </c:lvl>
                <c:lvl>
                  <c:pt idx="0">
                    <c:v>MCC-MCF-7</c:v>
                  </c:pt>
                  <c:pt idx="3">
                    <c:v>TamR-MCF-7</c:v>
                  </c:pt>
                </c:lvl>
              </c:multiLvlStrCache>
            </c:multiLvlStrRef>
          </c:cat>
          <c:val>
            <c:numRef>
              <c:f>Sheet1!$M$16:$M$21</c:f>
              <c:numCache>
                <c:formatCode>General</c:formatCode>
                <c:ptCount val="6"/>
                <c:pt idx="0">
                  <c:v>1.0</c:v>
                </c:pt>
                <c:pt idx="1">
                  <c:v>0.871785346593502</c:v>
                </c:pt>
                <c:pt idx="2">
                  <c:v>0.43113238587516</c:v>
                </c:pt>
                <c:pt idx="3">
                  <c:v>1.0</c:v>
                </c:pt>
                <c:pt idx="4">
                  <c:v>0.915226986451474</c:v>
                </c:pt>
                <c:pt idx="5">
                  <c:v>0.7625986953271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3531864"/>
        <c:axId val="-2103533720"/>
      </c:barChart>
      <c:catAx>
        <c:axId val="-210353186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03533720"/>
        <c:crosses val="autoZero"/>
        <c:auto val="1"/>
        <c:lblAlgn val="ctr"/>
        <c:lblOffset val="100"/>
        <c:noMultiLvlLbl val="0"/>
      </c:catAx>
      <c:valAx>
        <c:axId val="-21035337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SRB absorba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035318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61321378965001"/>
          <c:y val="0.0225518882323131"/>
          <c:w val="0.158871289843755"/>
          <c:h val="0.137429019383771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400" b="0">
          <a:latin typeface="Helvetica"/>
          <a:cs typeface="Helvetica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1C96E4-4F73-0541-8746-F2C89C3EC763}" type="datetimeFigureOut">
              <a:rPr lang="en-US" smtClean="0"/>
              <a:t>10/6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13CA3F-A609-6E4A-90A1-52ED876D15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2422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 smtClean="0"/>
              <a:t>siRNA</a:t>
            </a:r>
            <a:r>
              <a:rPr lang="en-US" dirty="0" smtClean="0"/>
              <a:t> #6 data are in ‘10-24-2014 JEN PDK4 </a:t>
            </a:r>
            <a:r>
              <a:rPr lang="en-US" dirty="0" err="1" smtClean="0"/>
              <a:t>siRNA</a:t>
            </a:r>
            <a:r>
              <a:rPr lang="en-US" dirty="0" smtClean="0"/>
              <a:t> 6.xlsx’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13CA3F-A609-6E4A-90A1-52ED876D152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934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9-19-2014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13CA3F-A609-6E4A-90A1-52ED876D152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344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86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794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344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15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890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536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442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53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185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404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053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5DCE8-0DD7-774C-BE0C-DD916EFF2E36}" type="datetimeFigureOut">
              <a:rPr lang="en-US" smtClean="0"/>
              <a:t>10/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90024-DAF7-4F45-B5F4-E1BA7DF9E3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403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1</a:t>
            </a: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7720892"/>
              </p:ext>
            </p:extLst>
          </p:nvPr>
        </p:nvGraphicFramePr>
        <p:xfrm>
          <a:off x="569216" y="369332"/>
          <a:ext cx="8574784" cy="6326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 flipH="1">
            <a:off x="5556779" y="3560830"/>
            <a:ext cx="95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>
                    <a:lumMod val="50000"/>
                  </a:schemeClr>
                </a:solidFill>
                <a:latin typeface="Helvetica"/>
                <a:cs typeface="Helvetica"/>
              </a:rPr>
              <a:t>PDK4</a:t>
            </a:r>
          </a:p>
        </p:txBody>
      </p:sp>
      <p:sp>
        <p:nvSpPr>
          <p:cNvPr id="5" name="Oval 4"/>
          <p:cNvSpPr/>
          <p:nvPr/>
        </p:nvSpPr>
        <p:spPr>
          <a:xfrm>
            <a:off x="5424599" y="3458767"/>
            <a:ext cx="902919" cy="601032"/>
          </a:xfrm>
          <a:prstGeom prst="ellipse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 flipH="1">
            <a:off x="5620920" y="1207040"/>
            <a:ext cx="95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>
                    <a:lumMod val="50000"/>
                  </a:schemeClr>
                </a:solidFill>
                <a:latin typeface="Helvetica"/>
                <a:cs typeface="Helvetica"/>
              </a:rPr>
              <a:t>PGM</a:t>
            </a:r>
          </a:p>
        </p:txBody>
      </p:sp>
      <p:sp>
        <p:nvSpPr>
          <p:cNvPr id="7" name="Oval 6"/>
          <p:cNvSpPr/>
          <p:nvPr/>
        </p:nvSpPr>
        <p:spPr>
          <a:xfrm>
            <a:off x="5488740" y="1104977"/>
            <a:ext cx="902919" cy="601032"/>
          </a:xfrm>
          <a:prstGeom prst="ellipse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6508949" y="6533458"/>
            <a:ext cx="2325781" cy="0"/>
          </a:xfrm>
          <a:prstGeom prst="straightConnector1">
            <a:avLst/>
          </a:prstGeom>
          <a:ln>
            <a:headEnd type="non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 flipH="1">
            <a:off x="3261587" y="2884085"/>
            <a:ext cx="95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>
                    <a:lumMod val="50000"/>
                  </a:schemeClr>
                </a:solidFill>
                <a:latin typeface="Helvetica"/>
                <a:cs typeface="Helvetica"/>
              </a:rPr>
              <a:t>GCK</a:t>
            </a:r>
          </a:p>
        </p:txBody>
      </p:sp>
      <p:sp>
        <p:nvSpPr>
          <p:cNvPr id="9" name="Oval 8"/>
          <p:cNvSpPr/>
          <p:nvPr/>
        </p:nvSpPr>
        <p:spPr>
          <a:xfrm>
            <a:off x="3261587" y="2782022"/>
            <a:ext cx="902919" cy="601032"/>
          </a:xfrm>
          <a:prstGeom prst="ellipse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6588723" y="6367607"/>
            <a:ext cx="203132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Higher in TamR-MCF-7</a:t>
            </a:r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1843129" y="6533458"/>
            <a:ext cx="1921800" cy="0"/>
          </a:xfrm>
          <a:prstGeom prst="straightConnector1">
            <a:avLst/>
          </a:prstGeom>
          <a:ln>
            <a:headEnd type="non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2038723" y="6367607"/>
            <a:ext cx="160140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Higher in MCF-7L</a:t>
            </a:r>
          </a:p>
        </p:txBody>
      </p:sp>
    </p:spTree>
    <p:extLst>
      <p:ext uri="{BB962C8B-B14F-4D97-AF65-F5344CB8AC3E}">
        <p14:creationId xmlns:p14="http://schemas.microsoft.com/office/powerpoint/2010/main" val="36345439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ight Bracket 4"/>
          <p:cNvSpPr/>
          <p:nvPr/>
        </p:nvSpPr>
        <p:spPr>
          <a:xfrm rot="16200000">
            <a:off x="2610483" y="1411727"/>
            <a:ext cx="135744" cy="1285859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2505996" y="1600027"/>
            <a:ext cx="337199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latin typeface="Helvetica"/>
                <a:cs typeface="Helvetica"/>
              </a:rPr>
              <a:t>*</a:t>
            </a:r>
          </a:p>
        </p:txBody>
      </p:sp>
      <p:sp>
        <p:nvSpPr>
          <p:cNvPr id="7" name="Right Bracket 6"/>
          <p:cNvSpPr/>
          <p:nvPr/>
        </p:nvSpPr>
        <p:spPr>
          <a:xfrm rot="16200000">
            <a:off x="4976215" y="1111894"/>
            <a:ext cx="185111" cy="1262175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4960824" y="1256470"/>
            <a:ext cx="330989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latin typeface="Helvetica"/>
                <a:cs typeface="Helvetica"/>
              </a:rPr>
              <a:t>*</a:t>
            </a:r>
          </a:p>
        </p:txBody>
      </p:sp>
      <p:sp>
        <p:nvSpPr>
          <p:cNvPr id="9" name="Right Bracket 8"/>
          <p:cNvSpPr/>
          <p:nvPr/>
        </p:nvSpPr>
        <p:spPr>
          <a:xfrm rot="16200000">
            <a:off x="7508683" y="1262480"/>
            <a:ext cx="135744" cy="1281859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7494109" y="1448779"/>
            <a:ext cx="33615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latin typeface="Helvetica"/>
                <a:cs typeface="Helvetica"/>
              </a:rPr>
              <a:t>*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0" y="0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2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242913" y="6145829"/>
            <a:ext cx="9378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11.0 </a:t>
            </a:r>
            <a:r>
              <a:rPr lang="en-US" dirty="0" err="1" smtClean="0">
                <a:latin typeface="Helvetica"/>
                <a:cs typeface="Helvetica"/>
              </a:rPr>
              <a:t>ug</a:t>
            </a:r>
            <a:endParaRPr lang="en-US" dirty="0" smtClean="0">
              <a:latin typeface="Helvetica"/>
              <a:cs typeface="Helvetica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45037" y="6152997"/>
            <a:ext cx="954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15.1 </a:t>
            </a:r>
            <a:r>
              <a:rPr lang="en-US" dirty="0" err="1" smtClean="0">
                <a:latin typeface="Helvetica"/>
                <a:cs typeface="Helvetica"/>
              </a:rPr>
              <a:t>ug</a:t>
            </a:r>
            <a:endParaRPr lang="en-US" dirty="0" smtClean="0">
              <a:latin typeface="Helvetica"/>
              <a:cs typeface="Helvetica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153865" y="6152997"/>
            <a:ext cx="954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13.6 </a:t>
            </a:r>
            <a:r>
              <a:rPr lang="en-US" dirty="0" err="1" smtClean="0">
                <a:latin typeface="Helvetica"/>
                <a:cs typeface="Helvetica"/>
              </a:rPr>
              <a:t>ug</a:t>
            </a:r>
            <a:endParaRPr lang="en-US" dirty="0" smtClean="0">
              <a:latin typeface="Helvetica"/>
              <a:cs typeface="Helvetica"/>
            </a:endParaRPr>
          </a:p>
        </p:txBody>
      </p:sp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41472527"/>
              </p:ext>
            </p:extLst>
          </p:nvPr>
        </p:nvGraphicFramePr>
        <p:xfrm>
          <a:off x="556810" y="1133523"/>
          <a:ext cx="8455583" cy="5073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637924" y="5426242"/>
            <a:ext cx="925654" cy="33855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MCF-7L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109035" y="5409365"/>
            <a:ext cx="925654" cy="33855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MCF-7L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584230" y="5426242"/>
            <a:ext cx="925654" cy="33855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MCF-7L</a:t>
            </a:r>
          </a:p>
        </p:txBody>
      </p:sp>
    </p:spTree>
    <p:extLst>
      <p:ext uri="{BB962C8B-B14F-4D97-AF65-F5344CB8AC3E}">
        <p14:creationId xmlns:p14="http://schemas.microsoft.com/office/powerpoint/2010/main" val="2998104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1230" t="5942" r="7431" b="11236"/>
          <a:stretch/>
        </p:blipFill>
        <p:spPr>
          <a:xfrm>
            <a:off x="209828" y="980703"/>
            <a:ext cx="3762249" cy="396676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222261" y="1844468"/>
            <a:ext cx="918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MCF-7L 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267033" y="3729058"/>
            <a:ext cx="1086356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TamR-MCF-7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5" name="Right Brace 4"/>
          <p:cNvSpPr/>
          <p:nvPr/>
        </p:nvSpPr>
        <p:spPr>
          <a:xfrm>
            <a:off x="4057701" y="1151931"/>
            <a:ext cx="176485" cy="1740808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sp>
        <p:nvSpPr>
          <p:cNvPr id="6" name="Right Brace 5"/>
          <p:cNvSpPr/>
          <p:nvPr/>
        </p:nvSpPr>
        <p:spPr>
          <a:xfrm>
            <a:off x="4062158" y="3130753"/>
            <a:ext cx="176485" cy="1740808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sp>
        <p:nvSpPr>
          <p:cNvPr id="7" name="Right Brace 6"/>
          <p:cNvSpPr/>
          <p:nvPr/>
        </p:nvSpPr>
        <p:spPr>
          <a:xfrm flipH="1">
            <a:off x="5042388" y="1151931"/>
            <a:ext cx="176485" cy="1740808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sp>
        <p:nvSpPr>
          <p:cNvPr id="8" name="Right Brace 7"/>
          <p:cNvSpPr/>
          <p:nvPr/>
        </p:nvSpPr>
        <p:spPr>
          <a:xfrm flipH="1">
            <a:off x="5046845" y="3130753"/>
            <a:ext cx="176485" cy="1740808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l="12340" t="6369" r="11214" b="8987"/>
          <a:stretch/>
        </p:blipFill>
        <p:spPr>
          <a:xfrm>
            <a:off x="5447204" y="994973"/>
            <a:ext cx="3567693" cy="3996524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080345" y="538367"/>
            <a:ext cx="20239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err="1" smtClean="0">
                <a:latin typeface="Helvetica"/>
                <a:cs typeface="Helvetica"/>
              </a:rPr>
              <a:t>cDNA</a:t>
            </a:r>
            <a:r>
              <a:rPr lang="en-US" sz="2000" dirty="0" smtClean="0">
                <a:latin typeface="Helvetica"/>
                <a:cs typeface="Helvetica"/>
              </a:rPr>
              <a:t> sequence</a:t>
            </a:r>
            <a:endParaRPr lang="en-US" sz="2000" dirty="0">
              <a:latin typeface="Helvetica"/>
              <a:cs typeface="Helvetica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931533" y="538367"/>
            <a:ext cx="29364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Helvetica"/>
                <a:cs typeface="Helvetica"/>
              </a:rPr>
              <a:t>genomic DNA sequence</a:t>
            </a:r>
            <a:endParaRPr lang="en-US" sz="2000" dirty="0">
              <a:latin typeface="Helvetica"/>
              <a:cs typeface="Helvetica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2491" y="5228258"/>
            <a:ext cx="53247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wild type:  	5’GATGCCTGT3’</a:t>
            </a:r>
          </a:p>
          <a:p>
            <a:r>
              <a:rPr lang="en-US" dirty="0">
                <a:latin typeface="Helvetica"/>
                <a:cs typeface="Helvetica"/>
              </a:rPr>
              <a:t>	</a:t>
            </a:r>
            <a:r>
              <a:rPr lang="en-US" dirty="0" smtClean="0">
                <a:latin typeface="Helvetica"/>
                <a:cs typeface="Helvetica"/>
              </a:rPr>
              <a:t>		3’CTACGGACA 5’	 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677009" y="5224983"/>
            <a:ext cx="46432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A144T mutation:  	5’GAT</a:t>
            </a:r>
            <a:r>
              <a:rPr lang="en-US" dirty="0" smtClean="0">
                <a:solidFill>
                  <a:srgbClr val="FF0000"/>
                </a:solidFill>
                <a:latin typeface="Helvetica"/>
                <a:cs typeface="Helvetica"/>
              </a:rPr>
              <a:t>A</a:t>
            </a:r>
            <a:r>
              <a:rPr lang="en-US" dirty="0" smtClean="0">
                <a:latin typeface="Helvetica"/>
                <a:cs typeface="Helvetica"/>
              </a:rPr>
              <a:t>CCTGT3’</a:t>
            </a:r>
          </a:p>
          <a:p>
            <a:r>
              <a:rPr lang="en-US" dirty="0" smtClean="0">
                <a:latin typeface="Helvetica"/>
                <a:cs typeface="Helvetica"/>
              </a:rPr>
              <a:t>				3’CTA</a:t>
            </a:r>
            <a:r>
              <a:rPr lang="en-US" dirty="0" smtClean="0">
                <a:solidFill>
                  <a:srgbClr val="FF0000"/>
                </a:solidFill>
                <a:latin typeface="Helvetica"/>
                <a:cs typeface="Helvetica"/>
              </a:rPr>
              <a:t>T</a:t>
            </a:r>
            <a:r>
              <a:rPr lang="en-US" dirty="0" smtClean="0">
                <a:latin typeface="Helvetica"/>
                <a:cs typeface="Helvetica"/>
              </a:rPr>
              <a:t>GGACA 5’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0" y="0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3</a:t>
            </a:r>
          </a:p>
        </p:txBody>
      </p:sp>
      <p:sp>
        <p:nvSpPr>
          <p:cNvPr id="15" name="Left Brace 14"/>
          <p:cNvSpPr/>
          <p:nvPr/>
        </p:nvSpPr>
        <p:spPr>
          <a:xfrm rot="5400000">
            <a:off x="2453862" y="5062445"/>
            <a:ext cx="81884" cy="406964"/>
          </a:xfrm>
          <a:prstGeom prst="leftBrace">
            <a:avLst/>
          </a:prstGeom>
          <a:ln w="190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2291186" y="4927968"/>
            <a:ext cx="444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Helvetica"/>
                <a:cs typeface="Helvetica"/>
              </a:rPr>
              <a:t>Ala</a:t>
            </a:r>
            <a:endParaRPr lang="en-US" sz="1400" dirty="0" smtClean="0">
              <a:latin typeface="Helvetica"/>
              <a:cs typeface="Helvetica"/>
            </a:endParaRPr>
          </a:p>
        </p:txBody>
      </p:sp>
      <p:sp>
        <p:nvSpPr>
          <p:cNvPr id="17" name="Left Brace 16"/>
          <p:cNvSpPr/>
          <p:nvPr/>
        </p:nvSpPr>
        <p:spPr>
          <a:xfrm rot="5400000">
            <a:off x="2944812" y="5072165"/>
            <a:ext cx="81884" cy="406964"/>
          </a:xfrm>
          <a:prstGeom prst="leftBrace">
            <a:avLst/>
          </a:prstGeom>
          <a:ln w="190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2760731" y="4937688"/>
            <a:ext cx="4938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Helvetica"/>
                <a:cs typeface="Helvetica"/>
              </a:rPr>
              <a:t>Cys</a:t>
            </a:r>
            <a:endParaRPr lang="en-US" sz="1400" dirty="0" smtClean="0">
              <a:latin typeface="Helvetica"/>
              <a:cs typeface="Helvetica"/>
            </a:endParaRPr>
          </a:p>
        </p:txBody>
      </p:sp>
      <p:sp>
        <p:nvSpPr>
          <p:cNvPr id="19" name="Left Brace 18"/>
          <p:cNvSpPr/>
          <p:nvPr/>
        </p:nvSpPr>
        <p:spPr>
          <a:xfrm rot="5400000">
            <a:off x="1980209" y="5072165"/>
            <a:ext cx="81884" cy="406964"/>
          </a:xfrm>
          <a:prstGeom prst="leftBrace">
            <a:avLst/>
          </a:prstGeom>
          <a:ln w="190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1796128" y="4937688"/>
            <a:ext cx="49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Asp</a:t>
            </a:r>
          </a:p>
        </p:txBody>
      </p:sp>
      <p:sp>
        <p:nvSpPr>
          <p:cNvPr id="21" name="Left Brace 20"/>
          <p:cNvSpPr/>
          <p:nvPr/>
        </p:nvSpPr>
        <p:spPr>
          <a:xfrm rot="5400000">
            <a:off x="7426320" y="5064063"/>
            <a:ext cx="81884" cy="406964"/>
          </a:xfrm>
          <a:prstGeom prst="leftBrace">
            <a:avLst/>
          </a:prstGeom>
          <a:ln w="190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7253800" y="492466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Helvetica"/>
                <a:cs typeface="Helvetica"/>
              </a:rPr>
              <a:t>Thr</a:t>
            </a:r>
            <a:endParaRPr lang="en-US" sz="1400" dirty="0" smtClean="0">
              <a:latin typeface="Helvetica"/>
              <a:cs typeface="Helvetica"/>
            </a:endParaRPr>
          </a:p>
        </p:txBody>
      </p:sp>
      <p:sp>
        <p:nvSpPr>
          <p:cNvPr id="23" name="Left Brace 22"/>
          <p:cNvSpPr/>
          <p:nvPr/>
        </p:nvSpPr>
        <p:spPr>
          <a:xfrm rot="5400000">
            <a:off x="7907426" y="5068861"/>
            <a:ext cx="81884" cy="406964"/>
          </a:xfrm>
          <a:prstGeom prst="leftBrace">
            <a:avLst/>
          </a:prstGeom>
          <a:ln w="190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7723345" y="4934384"/>
            <a:ext cx="4938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Helvetica"/>
                <a:cs typeface="Helvetica"/>
              </a:rPr>
              <a:t>Cys</a:t>
            </a:r>
            <a:endParaRPr lang="en-US" sz="1400" dirty="0" smtClean="0">
              <a:latin typeface="Helvetica"/>
              <a:cs typeface="Helvetica"/>
            </a:endParaRPr>
          </a:p>
        </p:txBody>
      </p:sp>
      <p:sp>
        <p:nvSpPr>
          <p:cNvPr id="25" name="Left Brace 24"/>
          <p:cNvSpPr/>
          <p:nvPr/>
        </p:nvSpPr>
        <p:spPr>
          <a:xfrm rot="5400000">
            <a:off x="6942823" y="5068861"/>
            <a:ext cx="81884" cy="406964"/>
          </a:xfrm>
          <a:prstGeom prst="leftBrace">
            <a:avLst/>
          </a:prstGeom>
          <a:ln w="190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6758742" y="4934384"/>
            <a:ext cx="49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Asp</a:t>
            </a:r>
          </a:p>
        </p:txBody>
      </p:sp>
    </p:spTree>
    <p:extLst>
      <p:ext uri="{BB962C8B-B14F-4D97-AF65-F5344CB8AC3E}">
        <p14:creationId xmlns:p14="http://schemas.microsoft.com/office/powerpoint/2010/main" val="42571536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-2671"/>
            <a:ext cx="1313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4a</a:t>
            </a: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7554229"/>
              </p:ext>
            </p:extLst>
          </p:nvPr>
        </p:nvGraphicFramePr>
        <p:xfrm>
          <a:off x="1351652" y="737115"/>
          <a:ext cx="5928396" cy="47855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0190011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0" y="0"/>
            <a:ext cx="1313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4b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9344396"/>
              </p:ext>
            </p:extLst>
          </p:nvPr>
        </p:nvGraphicFramePr>
        <p:xfrm>
          <a:off x="575777" y="1071438"/>
          <a:ext cx="8051952" cy="40393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1564972" y="2515974"/>
            <a:ext cx="351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497539" y="2515974"/>
            <a:ext cx="351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27307" y="2515974"/>
            <a:ext cx="351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784546" y="2515974"/>
            <a:ext cx="351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62132" y="3484300"/>
            <a:ext cx="3386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B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58489" y="3484300"/>
            <a:ext cx="3386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B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679239" y="203136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396390" y="203136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340296" y="2337981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b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593108" y="2337981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b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412670" y="2337981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b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599664" y="274259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c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326662" y="272458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c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295544" y="27692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c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577674" y="3129198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d</a:t>
            </a:r>
            <a:endParaRPr lang="en-US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773529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dirty="0" smtClean="0">
            <a:latin typeface="Helvetica"/>
            <a:cs typeface="Helvetica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785</TotalTime>
  <Words>133</Words>
  <Application>Microsoft Macintosh PowerPoint</Application>
  <PresentationFormat>On-screen Show (4:3)</PresentationFormat>
  <Paragraphs>57</Paragraphs>
  <Slides>5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innesot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y Skildum</dc:creator>
  <cp:lastModifiedBy>Andy Skildum</cp:lastModifiedBy>
  <cp:revision>84</cp:revision>
  <cp:lastPrinted>2015-06-05T17:37:09Z</cp:lastPrinted>
  <dcterms:created xsi:type="dcterms:W3CDTF">2015-03-06T21:21:27Z</dcterms:created>
  <dcterms:modified xsi:type="dcterms:W3CDTF">2015-10-13T15:25:48Z</dcterms:modified>
</cp:coreProperties>
</file>